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7" d="100"/>
          <a:sy n="107" d="100"/>
        </p:scale>
        <p:origin x="7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rey Seth" userId="70eca398-0873-4d6b-b861-058662170773" providerId="ADAL" clId="{9420A5C3-CD82-464C-B3EE-2B72DC31EB97}"/>
    <pc:docChg chg="modSld">
      <pc:chgData name="Shrey Seth" userId="70eca398-0873-4d6b-b861-058662170773" providerId="ADAL" clId="{9420A5C3-CD82-464C-B3EE-2B72DC31EB97}" dt="2025-04-10T11:11:05.847" v="10" actId="20577"/>
      <pc:docMkLst>
        <pc:docMk/>
      </pc:docMkLst>
      <pc:sldChg chg="modSp mod">
        <pc:chgData name="Shrey Seth" userId="70eca398-0873-4d6b-b861-058662170773" providerId="ADAL" clId="{9420A5C3-CD82-464C-B3EE-2B72DC31EB97}" dt="2025-04-10T11:11:05.847" v="10" actId="20577"/>
        <pc:sldMkLst>
          <pc:docMk/>
          <pc:sldMk cId="763056048" sldId="258"/>
        </pc:sldMkLst>
        <pc:spChg chg="mod">
          <ac:chgData name="Shrey Seth" userId="70eca398-0873-4d6b-b861-058662170773" providerId="ADAL" clId="{9420A5C3-CD82-464C-B3EE-2B72DC31EB97}" dt="2025-04-10T11:11:03.449" v="9" actId="20577"/>
          <ac:spMkLst>
            <pc:docMk/>
            <pc:sldMk cId="763056048" sldId="258"/>
            <ac:spMk id="4" creationId="{EAAC926B-0BEA-AD89-EB2B-356D71CA8EC2}"/>
          </ac:spMkLst>
        </pc:spChg>
        <pc:spChg chg="mod">
          <ac:chgData name="Shrey Seth" userId="70eca398-0873-4d6b-b861-058662170773" providerId="ADAL" clId="{9420A5C3-CD82-464C-B3EE-2B72DC31EB97}" dt="2025-04-10T11:11:05.847" v="10" actId="20577"/>
          <ac:spMkLst>
            <pc:docMk/>
            <pc:sldMk cId="763056048" sldId="258"/>
            <ac:spMk id="5" creationId="{9FF14C37-DEE7-21FB-A8D3-870E73072A21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A555A4D-F97A-AEFD-4023-11B9360189D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ECD14C78-BBDC-35D0-D139-6F6D507D598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A03EA19-8C2B-649B-F664-446D1CBFC3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D7223F6-2555-C970-635E-135927FDD0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A52E164-705D-C1CE-C853-E8BA65195C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51887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9C8ED4-A65B-3F96-9BF8-A3CF42F5B90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A699C71E-9280-0766-4D91-326E710078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FFC21BB-76CF-457D-FA5A-0E7F3BCA82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03836E2-4692-065A-A2A4-8E6C4B6652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0A1D3A9-52AA-F41B-3278-30C4CB551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3927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73CDEBAE-C4EB-ED47-CF86-EBB4F4879D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FF971C77-D7C7-3B3C-5946-8C5BC4F779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11C4934-86F4-6829-E437-395EFD27E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92601D0-10F2-51C6-D91C-29BCDE0361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AA3141-4E08-C572-C6E0-96D12EA6A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50601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956E458-B879-BCF0-422A-A37141B36F0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2498666-BE13-6037-28FC-0228CDFCE84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35DB45-5E20-2E9E-49C2-B0EF388262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E920504-F8CB-CB4E-EAB9-C38A9DF4C6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F1BEA4D-6E71-6AA4-1E29-9B480D77AC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19662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9055454-D967-8207-ED96-444DAF5657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2D23E9E-56B2-BDB6-E0F3-C5EFBE5F83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73A3259-13E8-CA12-BB44-688E470F5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F18DE6-1E49-062C-7A08-0B5940D354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98602E3-2E90-923D-6332-D4C8BF9297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537173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A3C579-148F-5EB4-B683-9425156C5B7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C8DD307-F141-35D5-7F13-62F1872B53C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D85DCA9-65C7-BE12-9C92-FF9186C782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ACB1456-CD1C-CE8B-2F4E-5C4D0B775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BAC0233-1E7E-DAEE-B2BF-F52A437CD1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52DD69B9-1F6B-1127-F501-CA2348382B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3394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6BA26F0-1C09-6085-7906-76F6ED10EC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A98509E-BEAD-3865-3C30-36D5613A7A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F2928A9-E012-BCF6-08E5-8732A1C511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4BDA42A-EB37-C732-DBFA-11350B6E7F7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9885EBDD-DA01-30F2-5347-B2BC7FFA2FC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9157F66-4B0A-D45B-8B19-DCD8D4610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A40E129-9F29-3047-5384-9776571532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A66AE1E3-8FF2-BD9B-76F1-A482FC7C2B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64269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180492-CBD9-0D48-884A-0D8D142CCF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4F30E014-8FA8-A25F-4442-9D1588E80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CA900388-73C0-45A5-EB24-8C2221F31B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E5824F8-75BF-39BE-74DC-5C545A02A4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348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43F4FEEB-F7BF-9207-E13F-E6850A620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B758F46-5EAF-8F06-365C-3A9E620AE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2BBD8569-E217-EC03-5C8B-9A4021794E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1943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024EADB-6744-36E2-9CD3-1CAF82985A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476468E-2DE8-A34D-E765-0535B71A08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96201FDD-C0F1-F5D5-EE44-D2C2CB6D84D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43FD7DB7-38F2-F985-ECE5-25BE13CA27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71C2D0F-3C9E-27C2-D7C8-6DDC4FA864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8CA8668-E7AD-9D4B-9A8C-D9A34C23CF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1205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67A7641-0673-A2A9-7010-0A741284C7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8D72B0C7-3763-D2EF-16BD-2CAB8E5039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84FAF45-3C83-37A7-6F61-6F040C2139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E9700EEF-2D99-1A72-1CBE-F0EA991E55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E85EDC-5DE0-BA9B-A4FE-8AD5296B7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9811BEE-EAD1-D66E-5D72-86DFF18DE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81862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4C55045-395B-097B-7B80-F0FD6F8AFD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FA21AA4-7F97-CC3A-1E0E-65A2B5AE06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252D0BD-1149-9E31-97C9-0D1606F4DC3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6D2370-EEF6-4678-9570-57E3ED3125E5}" type="datetimeFigureOut">
              <a:rPr kumimoji="1" lang="ja-JP" altLang="en-US" smtClean="0"/>
              <a:t>2025/8/28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AB2B6A4-F854-3E34-F228-263ABBD2024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0C1FA5-D5AA-2F79-969F-FED51EDE96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F7BCC7-AD8B-4BEF-83F8-049C374D378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2052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ECEBAD17-91E1-37FD-6FDA-F562B67DCF7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C2A9B7F0-1AD4-7A86-230B-20CAB13D788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2728148"/>
              </p:ext>
            </p:extLst>
          </p:nvPr>
        </p:nvGraphicFramePr>
        <p:xfrm>
          <a:off x="912000" y="948327"/>
          <a:ext cx="10368000" cy="499236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780000">
                  <a:extLst>
                    <a:ext uri="{9D8B030D-6E8A-4147-A177-3AD203B41FA5}">
                      <a16:colId xmlns:a16="http://schemas.microsoft.com/office/drawing/2014/main" val="695885514"/>
                    </a:ext>
                  </a:extLst>
                </a:gridCol>
                <a:gridCol w="2196000">
                  <a:extLst>
                    <a:ext uri="{9D8B030D-6E8A-4147-A177-3AD203B41FA5}">
                      <a16:colId xmlns:a16="http://schemas.microsoft.com/office/drawing/2014/main" val="406191321"/>
                    </a:ext>
                  </a:extLst>
                </a:gridCol>
                <a:gridCol w="2196000">
                  <a:extLst>
                    <a:ext uri="{9D8B030D-6E8A-4147-A177-3AD203B41FA5}">
                      <a16:colId xmlns:a16="http://schemas.microsoft.com/office/drawing/2014/main" val="3793145123"/>
                    </a:ext>
                  </a:extLst>
                </a:gridCol>
                <a:gridCol w="2196000">
                  <a:extLst>
                    <a:ext uri="{9D8B030D-6E8A-4147-A177-3AD203B41FA5}">
                      <a16:colId xmlns:a16="http://schemas.microsoft.com/office/drawing/2014/main" val="2763354669"/>
                    </a:ext>
                  </a:extLst>
                </a:gridCol>
              </a:tblGrid>
              <a:tr h="832061">
                <a:tc>
                  <a:txBody>
                    <a:bodyPr/>
                    <a:lstStyle/>
                    <a:p>
                      <a:pPr algn="ctr"/>
                      <a:endParaRPr kumimoji="1" lang="ja-JP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arget AE</a:t>
                      </a:r>
                      <a:endParaRPr kumimoji="1" lang="ja-JP" altLang="en-US" sz="2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ther AEs</a:t>
                      </a:r>
                      <a:endParaRPr kumimoji="1" lang="ja-JP" altLang="en-US" sz="2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kumimoji="1" lang="ja-JP" altLang="en-US" sz="20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6982631"/>
                  </a:ext>
                </a:extLst>
              </a:tr>
              <a:tr h="8320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 D</a:t>
                      </a:r>
                      <a:r>
                        <a:rPr kumimoji="1" lang="en-US" altLang="ja-JP" sz="2000" i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d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 D</a:t>
                      </a:r>
                      <a:r>
                        <a:rPr kumimoji="1" lang="en-US" altLang="ja-JP" sz="2000" i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2000" i="1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0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+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93966367"/>
                  </a:ext>
                </a:extLst>
              </a:tr>
              <a:tr h="8320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ly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 D</a:t>
                      </a:r>
                      <a:r>
                        <a:rPr kumimoji="1" lang="en-US" altLang="ja-JP" sz="2000" i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kumimoji="1" lang="ja-JP" altLang="en-US" sz="2000" i="1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+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01738"/>
                  </a:ext>
                </a:extLst>
              </a:tr>
              <a:tr h="83206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nly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 D</a:t>
                      </a:r>
                      <a:r>
                        <a:rPr kumimoji="1" lang="en-US" altLang="ja-JP" sz="2000" i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2000" i="1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1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10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1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25875380"/>
                  </a:ext>
                </a:extLst>
              </a:tr>
              <a:tr h="8320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ither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 D</a:t>
                      </a:r>
                      <a:r>
                        <a:rPr kumimoji="1" lang="en-US" altLang="ja-JP" sz="2000" i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r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rug D</a:t>
                      </a:r>
                      <a:r>
                        <a:rPr kumimoji="1" lang="en-US" altLang="ja-JP" sz="2000" i="1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kumimoji="1" lang="ja-JP" altLang="en-US" sz="2000" i="1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1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0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0+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5664048"/>
                  </a:ext>
                </a:extLst>
              </a:tr>
              <a:tr h="83206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otal</a:t>
                      </a:r>
                      <a:endParaRPr kumimoji="1" lang="ja-JP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1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0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20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kumimoji="1" lang="en-US" altLang="ja-JP" sz="2000" baseline="-25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++</a:t>
                      </a:r>
                      <a:endParaRPr kumimoji="1" lang="ja-JP" altLang="en-US" sz="2000" baseline="-25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1007359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64681668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46</Words>
  <Application>Microsoft Office PowerPoint</Application>
  <PresentationFormat>ワイド画面</PresentationFormat>
  <Paragraphs>2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照常 木下</dc:creator>
  <cp:lastModifiedBy>薬剤科共有ログインユーザー【固定】</cp:lastModifiedBy>
  <cp:revision>16</cp:revision>
  <dcterms:created xsi:type="dcterms:W3CDTF">2024-06-02T14:24:13Z</dcterms:created>
  <dcterms:modified xsi:type="dcterms:W3CDTF">2025-08-28T02:07:53Z</dcterms:modified>
</cp:coreProperties>
</file>